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-1170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7-10-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3727" y="188640"/>
            <a:ext cx="5082493" cy="513203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23528" y="5445224"/>
            <a:ext cx="8640960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Chromosome behavior during PMC meiosis in autotetraploid rice hybrids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a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Zygoten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Pachyten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plotene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iakinesis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etaphase 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h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aphase I. </a:t>
            </a:r>
            <a:r>
              <a:rPr lang="en-US" altLang="zh-CN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elophase I.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 j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phase II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Prophase I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Metaphase II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altLang="zh-CN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naphase I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Telophase II. </a:t>
            </a:r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Tetrad stage. Bars 10μm.</a:t>
            </a:r>
            <a:endParaRPr lang="zh-CN" altLang="zh-CN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3928837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7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wjw</cp:lastModifiedBy>
  <cp:revision>3</cp:revision>
  <dcterms:modified xsi:type="dcterms:W3CDTF">2017-10-19T07:34:03Z</dcterms:modified>
</cp:coreProperties>
</file>